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810" y="11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nfortha\Dropbox\Nature%20Medicine\Resubmission\Bafilomycin%20712%20hivig%20and%20b12%20Ab%20block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nfortha\Dropbox\Nature%20Medicine\Resubmission\Bafilomycin%20712%20hivig%20and%20b12%20Ab%20block%20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nfortha\Dropbox\Nature%20Medicine\Resubmission\FcRn%20block%20HIVIG%20657%20bafilo%20summary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nfortha\Dropbox\PLoS%20Pathogens\New%20data%20for%20revisions\Summary%20den3%20comp.xlsx" TargetMode="External"/><Relationship Id="rId1" Type="http://schemas.openxmlformats.org/officeDocument/2006/relationships/themeOverride" Target="../theme/themeOverride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nfortha\Dropbox\PLoS%20Pathogens\New%20data%20for%20revisions\2013-09-19%20TRA%202%20assays%20of%20pH%204-7.4%20and%202-12%20hour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strRef>
              <c:f>Sheet1!$C$4</c:f>
              <c:strCache>
                <c:ptCount val="1"/>
                <c:pt idx="0">
                  <c:v>Neg antibody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prstClr val="black"/>
              </a:solidFill>
            </a:ln>
          </c:spPr>
          <c:cat>
            <c:numRef>
              <c:f>Sheet1!$A$5:$A$8</c:f>
              <c:numCache>
                <c:formatCode>General</c:formatCode>
                <c:ptCount val="4"/>
                <c:pt idx="0">
                  <c:v>200</c:v>
                </c:pt>
                <c:pt idx="1">
                  <c:v>100</c:v>
                </c:pt>
                <c:pt idx="2">
                  <c:v>20</c:v>
                </c:pt>
                <c:pt idx="3">
                  <c:v>0</c:v>
                </c:pt>
              </c:numCache>
            </c:numRef>
          </c:cat>
          <c:val>
            <c:numRef>
              <c:f>Sheet1!$C$5:$C$8</c:f>
              <c:numCache>
                <c:formatCode>General</c:formatCode>
                <c:ptCount val="4"/>
                <c:pt idx="0">
                  <c:v>0.71801534877816686</c:v>
                </c:pt>
                <c:pt idx="1">
                  <c:v>0.13483908262409641</c:v>
                </c:pt>
                <c:pt idx="2">
                  <c:v>5.3930919060277575E-2</c:v>
                </c:pt>
                <c:pt idx="3">
                  <c:v>3.1896423345817035E-2</c:v>
                </c:pt>
              </c:numCache>
            </c:numRef>
          </c:val>
        </c:ser>
        <c:ser>
          <c:idx val="1"/>
          <c:order val="1"/>
          <c:tx>
            <c:strRef>
              <c:f>Sheet1!$D$4</c:f>
              <c:strCache>
                <c:ptCount val="1"/>
                <c:pt idx="0">
                  <c:v>Anti-FcRn antibody  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cat>
            <c:numRef>
              <c:f>Sheet1!$A$5:$A$8</c:f>
              <c:numCache>
                <c:formatCode>General</c:formatCode>
                <c:ptCount val="4"/>
                <c:pt idx="0">
                  <c:v>200</c:v>
                </c:pt>
                <c:pt idx="1">
                  <c:v>100</c:v>
                </c:pt>
                <c:pt idx="2">
                  <c:v>20</c:v>
                </c:pt>
                <c:pt idx="3">
                  <c:v>0</c:v>
                </c:pt>
              </c:numCache>
            </c:numRef>
          </c:cat>
          <c:val>
            <c:numRef>
              <c:f>Sheet1!$D$5:$D$8</c:f>
              <c:numCache>
                <c:formatCode>General</c:formatCode>
                <c:ptCount val="4"/>
                <c:pt idx="0">
                  <c:v>0.17688786772356238</c:v>
                </c:pt>
                <c:pt idx="1">
                  <c:v>6.0244129311898674E-2</c:v>
                </c:pt>
                <c:pt idx="2">
                  <c:v>5.1586756906407884E-2</c:v>
                </c:pt>
                <c:pt idx="3">
                  <c:v>3.2706574795151863E-2</c:v>
                </c:pt>
              </c:numCache>
            </c:numRef>
          </c:val>
        </c:ser>
        <c:ser>
          <c:idx val="2"/>
          <c:order val="2"/>
          <c:tx>
            <c:strRef>
              <c:f>Sheet1!$E$4</c:f>
              <c:strCache>
                <c:ptCount val="1"/>
                <c:pt idx="0">
                  <c:v>Bafilomycin A1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cat>
            <c:numRef>
              <c:f>Sheet1!$A$5:$A$8</c:f>
              <c:numCache>
                <c:formatCode>General</c:formatCode>
                <c:ptCount val="4"/>
                <c:pt idx="0">
                  <c:v>200</c:v>
                </c:pt>
                <c:pt idx="1">
                  <c:v>100</c:v>
                </c:pt>
                <c:pt idx="2">
                  <c:v>20</c:v>
                </c:pt>
                <c:pt idx="3">
                  <c:v>0</c:v>
                </c:pt>
              </c:numCache>
            </c:numRef>
          </c:cat>
          <c:val>
            <c:numRef>
              <c:f>Sheet1!$E$5:$E$8</c:f>
              <c:numCache>
                <c:formatCode>General</c:formatCode>
                <c:ptCount val="4"/>
                <c:pt idx="0">
                  <c:v>7.2067469349847771E-2</c:v>
                </c:pt>
                <c:pt idx="1">
                  <c:v>3.6465981310490905E-2</c:v>
                </c:pt>
                <c:pt idx="2">
                  <c:v>3.1064797056060252E-2</c:v>
                </c:pt>
                <c:pt idx="3">
                  <c:v>3.4189648225758991E-2</c:v>
                </c:pt>
              </c:numCache>
            </c:numRef>
          </c:val>
        </c:ser>
        <c:axId val="78359936"/>
        <c:axId val="78374400"/>
      </c:barChart>
      <c:catAx>
        <c:axId val="7835993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/>
                  <a:t>HIVIG (µg/ml)</a:t>
                </a:r>
              </a:p>
            </c:rich>
          </c:tx>
          <c:layout>
            <c:manualLayout>
              <c:xMode val="edge"/>
              <c:yMode val="edge"/>
              <c:x val="0.4663330094923035"/>
              <c:y val="0.84848373545143596"/>
            </c:manualLayout>
          </c:layout>
        </c:title>
        <c:numFmt formatCode="General" sourceLinked="1"/>
        <c:tickLblPos val="nextTo"/>
        <c:crossAx val="78374400"/>
        <c:crosses val="autoZero"/>
        <c:auto val="1"/>
        <c:lblAlgn val="ctr"/>
        <c:lblOffset val="100"/>
      </c:catAx>
      <c:valAx>
        <c:axId val="7837440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inoculum</a:t>
                </a:r>
              </a:p>
            </c:rich>
          </c:tx>
          <c:layout/>
        </c:title>
        <c:numFmt formatCode="General" sourceLinked="1"/>
        <c:tickLblPos val="nextTo"/>
        <c:crossAx val="7835993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4.9999917440569593E-2"/>
          <c:y val="3.4975675381668625E-2"/>
          <c:w val="0.89999988992075941"/>
          <c:h val="0.10541035142291789"/>
        </c:manualLayout>
      </c:layout>
    </c:legend>
    <c:plotVisOnly val="1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7316298141490596"/>
          <c:y val="0.21208820416435326"/>
          <c:w val="0.78846938691435675"/>
          <c:h val="0.55128314656870425"/>
        </c:manualLayout>
      </c:layout>
      <c:barChart>
        <c:barDir val="col"/>
        <c:grouping val="clustered"/>
        <c:ser>
          <c:idx val="0"/>
          <c:order val="0"/>
          <c:tx>
            <c:strRef>
              <c:f>Sheet1!$C$4</c:f>
              <c:strCache>
                <c:ptCount val="1"/>
                <c:pt idx="0">
                  <c:v>Neg antibody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prstClr val="black"/>
              </a:solidFill>
            </a:ln>
          </c:spPr>
          <c:cat>
            <c:numRef>
              <c:f>Sheet1!$A$10:$A$12</c:f>
              <c:numCache>
                <c:formatCode>General</c:formatCode>
                <c:ptCount val="3"/>
                <c:pt idx="0">
                  <c:v>100</c:v>
                </c:pt>
                <c:pt idx="1">
                  <c:v>20</c:v>
                </c:pt>
                <c:pt idx="2">
                  <c:v>0</c:v>
                </c:pt>
              </c:numCache>
            </c:numRef>
          </c:cat>
          <c:val>
            <c:numRef>
              <c:f>Sheet1!$C$10:$C$12</c:f>
              <c:numCache>
                <c:formatCode>General</c:formatCode>
                <c:ptCount val="3"/>
                <c:pt idx="0">
                  <c:v>1.5259250342835682</c:v>
                </c:pt>
                <c:pt idx="1">
                  <c:v>0.35319002226902985</c:v>
                </c:pt>
                <c:pt idx="2">
                  <c:v>3.1896423345817035E-2</c:v>
                </c:pt>
              </c:numCache>
            </c:numRef>
          </c:val>
        </c:ser>
        <c:ser>
          <c:idx val="1"/>
          <c:order val="1"/>
          <c:tx>
            <c:strRef>
              <c:f>Sheet1!$D$4</c:f>
              <c:strCache>
                <c:ptCount val="1"/>
                <c:pt idx="0">
                  <c:v>Anti-FcRn antibody  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cat>
            <c:numRef>
              <c:f>Sheet1!$A$10:$A$12</c:f>
              <c:numCache>
                <c:formatCode>General</c:formatCode>
                <c:ptCount val="3"/>
                <c:pt idx="0">
                  <c:v>100</c:v>
                </c:pt>
                <c:pt idx="1">
                  <c:v>20</c:v>
                </c:pt>
                <c:pt idx="2">
                  <c:v>0</c:v>
                </c:pt>
              </c:numCache>
            </c:numRef>
          </c:cat>
          <c:val>
            <c:numRef>
              <c:f>Sheet1!$D$10:$D$12</c:f>
              <c:numCache>
                <c:formatCode>General</c:formatCode>
                <c:ptCount val="3"/>
                <c:pt idx="0">
                  <c:v>0.2213046468120009</c:v>
                </c:pt>
                <c:pt idx="1">
                  <c:v>0.10012932423884843</c:v>
                </c:pt>
                <c:pt idx="2">
                  <c:v>3.2706574795151863E-2</c:v>
                </c:pt>
              </c:numCache>
            </c:numRef>
          </c:val>
        </c:ser>
        <c:ser>
          <c:idx val="2"/>
          <c:order val="2"/>
          <c:tx>
            <c:strRef>
              <c:f>Sheet1!$E$4</c:f>
              <c:strCache>
                <c:ptCount val="1"/>
                <c:pt idx="0">
                  <c:v>Bafilomycin A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numRef>
              <c:f>Sheet1!$A$10:$A$12</c:f>
              <c:numCache>
                <c:formatCode>General</c:formatCode>
                <c:ptCount val="3"/>
                <c:pt idx="0">
                  <c:v>100</c:v>
                </c:pt>
                <c:pt idx="1">
                  <c:v>20</c:v>
                </c:pt>
                <c:pt idx="2">
                  <c:v>0</c:v>
                </c:pt>
              </c:numCache>
            </c:numRef>
          </c:cat>
          <c:val>
            <c:numRef>
              <c:f>Sheet1!$E$10:$E$12</c:f>
              <c:numCache>
                <c:formatCode>General</c:formatCode>
                <c:ptCount val="3"/>
                <c:pt idx="0">
                  <c:v>4.7992470962850454E-2</c:v>
                </c:pt>
                <c:pt idx="1">
                  <c:v>6.1321406825019423E-2</c:v>
                </c:pt>
                <c:pt idx="2">
                  <c:v>3.4189648225758991E-2</c:v>
                </c:pt>
              </c:numCache>
            </c:numRef>
          </c:val>
        </c:ser>
        <c:axId val="78396032"/>
        <c:axId val="78410496"/>
      </c:barChart>
      <c:catAx>
        <c:axId val="7839603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/>
                  <a:t>IgG1b12 (µg/ml)</a:t>
                </a:r>
              </a:p>
            </c:rich>
          </c:tx>
          <c:layout>
            <c:manualLayout>
              <c:xMode val="edge"/>
              <c:yMode val="edge"/>
              <c:x val="0.43816851547201602"/>
              <c:y val="0.86615407251309084"/>
            </c:manualLayout>
          </c:layout>
        </c:title>
        <c:numFmt formatCode="General" sourceLinked="1"/>
        <c:tickLblPos val="nextTo"/>
        <c:crossAx val="78410496"/>
        <c:crosses val="autoZero"/>
        <c:auto val="1"/>
        <c:lblAlgn val="ctr"/>
        <c:lblOffset val="100"/>
      </c:catAx>
      <c:valAx>
        <c:axId val="78410496"/>
        <c:scaling>
          <c:orientation val="minMax"/>
          <c:max val="2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inoculum</a:t>
                </a:r>
              </a:p>
            </c:rich>
          </c:tx>
          <c:layout/>
        </c:title>
        <c:numFmt formatCode="@" sourceLinked="0"/>
        <c:tickLblPos val="nextTo"/>
        <c:crossAx val="78396032"/>
        <c:crosses val="autoZero"/>
        <c:crossBetween val="between"/>
        <c:majorUnit val="0.5"/>
      </c:valAx>
    </c:plotArea>
    <c:legend>
      <c:legendPos val="t"/>
      <c:layout/>
    </c:legend>
    <c:plotVisOnly val="1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strRef>
              <c:f>Sheet1!$R$2</c:f>
              <c:strCache>
                <c:ptCount val="1"/>
                <c:pt idx="0">
                  <c:v>No Bafilomycin A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V$3:$V$9</c:f>
                <c:numCache>
                  <c:formatCode>General</c:formatCode>
                  <c:ptCount val="7"/>
                  <c:pt idx="0">
                    <c:v>0.10461007701045773</c:v>
                  </c:pt>
                  <c:pt idx="1">
                    <c:v>6.6569353621929062E-2</c:v>
                  </c:pt>
                  <c:pt idx="2">
                    <c:v>0.16591014869209914</c:v>
                  </c:pt>
                  <c:pt idx="4">
                    <c:v>6.5559055736202354E-2</c:v>
                  </c:pt>
                  <c:pt idx="5">
                    <c:v>0.18413664692381113</c:v>
                  </c:pt>
                  <c:pt idx="6">
                    <c:v>0.106838014977849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M$3:$M$9</c:f>
              <c:numCache>
                <c:formatCode>General</c:formatCode>
                <c:ptCount val="7"/>
                <c:pt idx="0">
                  <c:v>200</c:v>
                </c:pt>
                <c:pt idx="1">
                  <c:v>50</c:v>
                </c:pt>
                <c:pt idx="2">
                  <c:v>12.5</c:v>
                </c:pt>
                <c:pt idx="4">
                  <c:v>200</c:v>
                </c:pt>
                <c:pt idx="5">
                  <c:v>50</c:v>
                </c:pt>
                <c:pt idx="6">
                  <c:v>12.5</c:v>
                </c:pt>
              </c:numCache>
            </c:numRef>
          </c:cat>
          <c:val>
            <c:numRef>
              <c:f>Sheet1!$R$3:$R$9</c:f>
              <c:numCache>
                <c:formatCode>General</c:formatCode>
                <c:ptCount val="7"/>
                <c:pt idx="0">
                  <c:v>2.4093897962788109</c:v>
                </c:pt>
                <c:pt idx="1">
                  <c:v>1.3120467535910361</c:v>
                </c:pt>
                <c:pt idx="2">
                  <c:v>0.92709447887785479</c:v>
                </c:pt>
                <c:pt idx="4">
                  <c:v>0.41597759641948623</c:v>
                </c:pt>
                <c:pt idx="5">
                  <c:v>0.45338078548630972</c:v>
                </c:pt>
                <c:pt idx="6">
                  <c:v>0.50773700311062853</c:v>
                </c:pt>
              </c:numCache>
            </c:numRef>
          </c:val>
        </c:ser>
        <c:ser>
          <c:idx val="1"/>
          <c:order val="1"/>
          <c:tx>
            <c:strRef>
              <c:f>Sheet1!$S$2</c:f>
              <c:strCache>
                <c:ptCount val="1"/>
                <c:pt idx="0">
                  <c:v>Bafilomycin A1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prstClr val="black"/>
              </a:solidFill>
            </a:ln>
          </c:spPr>
          <c:errBars>
            <c:errBarType val="plus"/>
            <c:errValType val="cust"/>
            <c:plus>
              <c:numRef>
                <c:f>Sheet1!$W$3:$W$9</c:f>
                <c:numCache>
                  <c:formatCode>General</c:formatCode>
                  <c:ptCount val="7"/>
                  <c:pt idx="0">
                    <c:v>7.397049483454203E-2</c:v>
                  </c:pt>
                  <c:pt idx="1">
                    <c:v>4.7071641365271304E-2</c:v>
                  </c:pt>
                  <c:pt idx="2">
                    <c:v>0.1173161912078511</c:v>
                  </c:pt>
                  <c:pt idx="4">
                    <c:v>4.6357252879255496E-2</c:v>
                  </c:pt>
                  <c:pt idx="5">
                    <c:v>0.13020427170477986</c:v>
                  </c:pt>
                  <c:pt idx="6">
                    <c:v>7.55458848793471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M$3:$M$9</c:f>
              <c:numCache>
                <c:formatCode>General</c:formatCode>
                <c:ptCount val="7"/>
                <c:pt idx="0">
                  <c:v>200</c:v>
                </c:pt>
                <c:pt idx="1">
                  <c:v>50</c:v>
                </c:pt>
                <c:pt idx="2">
                  <c:v>12.5</c:v>
                </c:pt>
                <c:pt idx="4">
                  <c:v>200</c:v>
                </c:pt>
                <c:pt idx="5">
                  <c:v>50</c:v>
                </c:pt>
                <c:pt idx="6">
                  <c:v>12.5</c:v>
                </c:pt>
              </c:numCache>
            </c:numRef>
          </c:cat>
          <c:val>
            <c:numRef>
              <c:f>Sheet1!$S$3:$S$9</c:f>
              <c:numCache>
                <c:formatCode>General</c:formatCode>
                <c:ptCount val="7"/>
                <c:pt idx="0">
                  <c:v>0.49005698115899565</c:v>
                </c:pt>
                <c:pt idx="1">
                  <c:v>0.48990211521148236</c:v>
                </c:pt>
                <c:pt idx="2">
                  <c:v>0.36646945818455307</c:v>
                </c:pt>
                <c:pt idx="4">
                  <c:v>0.45023784096241826</c:v>
                </c:pt>
                <c:pt idx="5">
                  <c:v>0.46148193148786054</c:v>
                </c:pt>
                <c:pt idx="6">
                  <c:v>0.45849040210739644</c:v>
                </c:pt>
              </c:numCache>
            </c:numRef>
          </c:val>
        </c:ser>
        <c:axId val="77752960"/>
        <c:axId val="78316288"/>
      </c:barChart>
      <c:catAx>
        <c:axId val="7775296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>
                    <a:latin typeface="Calibri"/>
                  </a:rPr>
                  <a:t>µ</a:t>
                </a:r>
                <a:r>
                  <a:rPr lang="en-US"/>
                  <a:t>g/ml</a:t>
                </a:r>
              </a:p>
            </c:rich>
          </c:tx>
          <c:layout/>
        </c:title>
        <c:numFmt formatCode="General" sourceLinked="1"/>
        <c:tickLblPos val="nextTo"/>
        <c:crossAx val="78316288"/>
        <c:crosses val="autoZero"/>
        <c:auto val="1"/>
        <c:lblAlgn val="ctr"/>
        <c:lblOffset val="100"/>
      </c:catAx>
      <c:valAx>
        <c:axId val="7831628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inoculum</a:t>
                </a:r>
              </a:p>
            </c:rich>
          </c:tx>
          <c:layout/>
        </c:title>
        <c:numFmt formatCode="General" sourceLinked="1"/>
        <c:tickLblPos val="nextTo"/>
        <c:crossAx val="77752960"/>
        <c:crosses val="autoZero"/>
        <c:crossBetween val="between"/>
      </c:valAx>
    </c:plotArea>
    <c:legend>
      <c:legendPos val="t"/>
      <c:layout/>
    </c:legend>
    <c:plotVisOnly val="1"/>
  </c:chart>
  <c:spPr>
    <a:ln>
      <a:noFill/>
    </a:ln>
  </c:sp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spPr>
            <a:solidFill>
              <a:sysClr val="window" lastClr="FFFFFF">
                <a:lumMod val="65000"/>
              </a:sysClr>
            </a:solidFill>
          </c:spPr>
          <c:errBars>
            <c:errBarType val="plus"/>
            <c:errValType val="cust"/>
            <c:plus>
              <c:numRef>
                <c:f>Sheet1!$Z$58:$Z$64</c:f>
                <c:numCache>
                  <c:formatCode>General</c:formatCode>
                  <c:ptCount val="7"/>
                  <c:pt idx="0">
                    <c:v>2.6499237486303982E-2</c:v>
                  </c:pt>
                  <c:pt idx="1">
                    <c:v>0.28947103710769584</c:v>
                  </c:pt>
                  <c:pt idx="2">
                    <c:v>0.42513639364273931</c:v>
                  </c:pt>
                  <c:pt idx="3">
                    <c:v>0.22229807928831019</c:v>
                  </c:pt>
                  <c:pt idx="4">
                    <c:v>8.7733575346911147E-2</c:v>
                  </c:pt>
                  <c:pt idx="5">
                    <c:v>7.8052361976952073E-4</c:v>
                  </c:pt>
                  <c:pt idx="6">
                    <c:v>2.651936650664784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U$58:$U$64</c:f>
              <c:numCache>
                <c:formatCode>General</c:formatCode>
                <c:ptCount val="7"/>
                <c:pt idx="0">
                  <c:v>0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numCache>
            </c:numRef>
          </c:cat>
          <c:val>
            <c:numRef>
              <c:f>Sheet1!$W$58:$W$64</c:f>
              <c:numCache>
                <c:formatCode>0.00</c:formatCode>
                <c:ptCount val="7"/>
                <c:pt idx="0">
                  <c:v>1.9178934924943754</c:v>
                </c:pt>
                <c:pt idx="1">
                  <c:v>1.6517800391995809</c:v>
                </c:pt>
                <c:pt idx="2">
                  <c:v>0.81436233806003555</c:v>
                </c:pt>
                <c:pt idx="3">
                  <c:v>0.67412043552400824</c:v>
                </c:pt>
                <c:pt idx="4">
                  <c:v>0.67533919466076864</c:v>
                </c:pt>
                <c:pt idx="5">
                  <c:v>0.34782667658502092</c:v>
                </c:pt>
                <c:pt idx="6">
                  <c:v>0.3353525936525304</c:v>
                </c:pt>
              </c:numCache>
            </c:numRef>
          </c:val>
        </c:ser>
        <c:gapWidth val="93"/>
        <c:axId val="78443264"/>
        <c:axId val="78445184"/>
      </c:barChart>
      <c:catAx>
        <c:axId val="7844326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/>
                  <a:t>Den3 (µg/ml)</a:t>
                </a:r>
              </a:p>
            </c:rich>
          </c:tx>
          <c:layout>
            <c:manualLayout>
              <c:xMode val="edge"/>
              <c:yMode val="edge"/>
              <c:x val="0.46547405176282658"/>
              <c:y val="0.82039907241212373"/>
            </c:manualLayout>
          </c:layout>
        </c:title>
        <c:numFmt formatCode="General" sourceLinked="1"/>
        <c:tickLblPos val="nextTo"/>
        <c:crossAx val="78445184"/>
        <c:crosses val="autoZero"/>
        <c:auto val="1"/>
        <c:lblAlgn val="ctr"/>
        <c:lblOffset val="100"/>
      </c:catAx>
      <c:valAx>
        <c:axId val="7844518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inoculum</a:t>
                </a:r>
              </a:p>
            </c:rich>
          </c:tx>
          <c:layout/>
        </c:title>
        <c:numFmt formatCode="0.0" sourceLinked="0"/>
        <c:tickLblPos val="nextTo"/>
        <c:crossAx val="78443264"/>
        <c:crosses val="autoZero"/>
        <c:crossBetween val="between"/>
      </c:valAx>
    </c:plotArea>
    <c:plotVisOnly val="1"/>
  </c:chart>
  <c:spPr>
    <a:ln>
      <a:noFill/>
    </a:ln>
  </c:spPr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lineChart>
        <c:grouping val="standard"/>
        <c:ser>
          <c:idx val="0"/>
          <c:order val="0"/>
          <c:tx>
            <c:strRef>
              <c:f>Sheet1!$P$37</c:f>
              <c:strCache>
                <c:ptCount val="1"/>
                <c:pt idx="0">
                  <c:v>6 hours</c:v>
                </c:pt>
              </c:strCache>
            </c:strRef>
          </c:tx>
          <c:spPr>
            <a:ln w="22225">
              <a:solidFill>
                <a:schemeClr val="tx1"/>
              </a:solidFill>
              <a:prstDash val="sysDash"/>
            </a:ln>
          </c:spPr>
          <c:marker>
            <c:symbol val="diamond"/>
            <c:size val="5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plus>
              <c:numRef>
                <c:f>Sheet1!$P$61:$P$67</c:f>
                <c:numCache>
                  <c:formatCode>General</c:formatCode>
                  <c:ptCount val="7"/>
                  <c:pt idx="0">
                    <c:v>4.3398044388901345E-2</c:v>
                  </c:pt>
                  <c:pt idx="1">
                    <c:v>0.10347366238342921</c:v>
                  </c:pt>
                  <c:pt idx="2">
                    <c:v>1.3959680037606401E-2</c:v>
                  </c:pt>
                  <c:pt idx="3">
                    <c:v>0.11050437938511327</c:v>
                  </c:pt>
                  <c:pt idx="4">
                    <c:v>2.6849970454262493E-2</c:v>
                  </c:pt>
                  <c:pt idx="5">
                    <c:v>0.14808708819491267</c:v>
                  </c:pt>
                  <c:pt idx="6">
                    <c:v>5.8000213529461893E-2</c:v>
                  </c:pt>
                </c:numCache>
              </c:numRef>
            </c:plus>
            <c:minus>
              <c:numRef>
                <c:f>Sheet1!$P$61:$P$67</c:f>
                <c:numCache>
                  <c:formatCode>General</c:formatCode>
                  <c:ptCount val="7"/>
                  <c:pt idx="0">
                    <c:v>4.3398044388901345E-2</c:v>
                  </c:pt>
                  <c:pt idx="1">
                    <c:v>0.10347366238342921</c:v>
                  </c:pt>
                  <c:pt idx="2">
                    <c:v>1.3959680037606401E-2</c:v>
                  </c:pt>
                  <c:pt idx="3">
                    <c:v>0.11050437938511327</c:v>
                  </c:pt>
                  <c:pt idx="4">
                    <c:v>2.6849970454262493E-2</c:v>
                  </c:pt>
                  <c:pt idx="5">
                    <c:v>0.14808708819491267</c:v>
                  </c:pt>
                  <c:pt idx="6">
                    <c:v>5.8000213529461893E-2</c:v>
                  </c:pt>
                </c:numCache>
              </c:numRef>
            </c:minus>
          </c:errBars>
          <c:cat>
            <c:numRef>
              <c:f>Sheet1!$M$38:$M$44</c:f>
              <c:numCache>
                <c:formatCode>General</c:formatCode>
                <c:ptCount val="7"/>
                <c:pt idx="0">
                  <c:v>4</c:v>
                </c:pt>
                <c:pt idx="1">
                  <c:v>4.5</c:v>
                </c:pt>
                <c:pt idx="2">
                  <c:v>5</c:v>
                </c:pt>
                <c:pt idx="3">
                  <c:v>5.5</c:v>
                </c:pt>
                <c:pt idx="4">
                  <c:v>6</c:v>
                </c:pt>
                <c:pt idx="5">
                  <c:v>6.5</c:v>
                </c:pt>
                <c:pt idx="6">
                  <c:v>7.4</c:v>
                </c:pt>
              </c:numCache>
            </c:numRef>
          </c:cat>
          <c:val>
            <c:numRef>
              <c:f>Sheet1!$P$38:$P$44</c:f>
              <c:numCache>
                <c:formatCode>0.00</c:formatCode>
                <c:ptCount val="7"/>
                <c:pt idx="0">
                  <c:v>0.10565074268258379</c:v>
                </c:pt>
                <c:pt idx="1">
                  <c:v>0.21999111650368294</c:v>
                </c:pt>
                <c:pt idx="2">
                  <c:v>0.32953666043825786</c:v>
                </c:pt>
                <c:pt idx="3">
                  <c:v>0.73797486947138125</c:v>
                </c:pt>
                <c:pt idx="4">
                  <c:v>0.59822749512668749</c:v>
                </c:pt>
                <c:pt idx="5">
                  <c:v>0.30355907507977686</c:v>
                </c:pt>
                <c:pt idx="6">
                  <c:v>0.1687130961236154</c:v>
                </c:pt>
              </c:numCache>
            </c:numRef>
          </c:val>
        </c:ser>
        <c:ser>
          <c:idx val="2"/>
          <c:order val="1"/>
          <c:tx>
            <c:strRef>
              <c:f>Sheet1!$Q$37</c:f>
              <c:strCache>
                <c:ptCount val="1"/>
                <c:pt idx="0">
                  <c:v>12 hours</c:v>
                </c:pt>
              </c:strCache>
            </c:strRef>
          </c:tx>
          <c:spPr>
            <a:ln w="22225">
              <a:solidFill>
                <a:schemeClr val="tx1"/>
              </a:solidFill>
              <a:prstDash val="solid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Q$61:$Q$67</c:f>
                <c:numCache>
                  <c:formatCode>General</c:formatCode>
                  <c:ptCount val="7"/>
                  <c:pt idx="0">
                    <c:v>0.28530163167476602</c:v>
                  </c:pt>
                  <c:pt idx="1">
                    <c:v>0.24578066977221871</c:v>
                  </c:pt>
                  <c:pt idx="2">
                    <c:v>0.12078498820012509</c:v>
                  </c:pt>
                  <c:pt idx="3">
                    <c:v>0.26757549832742666</c:v>
                  </c:pt>
                  <c:pt idx="4">
                    <c:v>0.18355775929310023</c:v>
                  </c:pt>
                  <c:pt idx="5">
                    <c:v>5.2322141947291713E-2</c:v>
                  </c:pt>
                  <c:pt idx="6">
                    <c:v>4.6433096940085789E-3</c:v>
                  </c:pt>
                </c:numCache>
              </c:numRef>
            </c:plus>
            <c:minus>
              <c:numRef>
                <c:f>Sheet1!$Q$61:$Q$67</c:f>
                <c:numCache>
                  <c:formatCode>General</c:formatCode>
                  <c:ptCount val="7"/>
                  <c:pt idx="0">
                    <c:v>0.28530163167476602</c:v>
                  </c:pt>
                  <c:pt idx="1">
                    <c:v>0.24578066977221871</c:v>
                  </c:pt>
                  <c:pt idx="2">
                    <c:v>0.12078498820012509</c:v>
                  </c:pt>
                  <c:pt idx="3">
                    <c:v>0.26757549832742666</c:v>
                  </c:pt>
                  <c:pt idx="4">
                    <c:v>0.18355775929310023</c:v>
                  </c:pt>
                  <c:pt idx="5">
                    <c:v>5.2322141947291713E-2</c:v>
                  </c:pt>
                  <c:pt idx="6">
                    <c:v>4.6433096940085789E-3</c:v>
                  </c:pt>
                </c:numCache>
              </c:numRef>
            </c:minus>
          </c:errBars>
          <c:cat>
            <c:numRef>
              <c:f>Sheet1!$M$38:$M$44</c:f>
              <c:numCache>
                <c:formatCode>General</c:formatCode>
                <c:ptCount val="7"/>
                <c:pt idx="0">
                  <c:v>4</c:v>
                </c:pt>
                <c:pt idx="1">
                  <c:v>4.5</c:v>
                </c:pt>
                <c:pt idx="2">
                  <c:v>5</c:v>
                </c:pt>
                <c:pt idx="3">
                  <c:v>5.5</c:v>
                </c:pt>
                <c:pt idx="4">
                  <c:v>6</c:v>
                </c:pt>
                <c:pt idx="5">
                  <c:v>6.5</c:v>
                </c:pt>
                <c:pt idx="6">
                  <c:v>7.4</c:v>
                </c:pt>
              </c:numCache>
            </c:numRef>
          </c:cat>
          <c:val>
            <c:numRef>
              <c:f>Sheet1!$Q$38:$Q$44</c:f>
              <c:numCache>
                <c:formatCode>0.00</c:formatCode>
                <c:ptCount val="7"/>
                <c:pt idx="0">
                  <c:v>0.59271227182974606</c:v>
                </c:pt>
                <c:pt idx="1">
                  <c:v>0.90930842396247991</c:v>
                </c:pt>
                <c:pt idx="2">
                  <c:v>1.2788119398532054</c:v>
                </c:pt>
                <c:pt idx="3">
                  <c:v>1.7258174671180084</c:v>
                </c:pt>
                <c:pt idx="4">
                  <c:v>1.4031945719301437</c:v>
                </c:pt>
                <c:pt idx="5">
                  <c:v>0.83455874595384749</c:v>
                </c:pt>
                <c:pt idx="6">
                  <c:v>0.2880401546900701</c:v>
                </c:pt>
              </c:numCache>
            </c:numRef>
          </c:val>
        </c:ser>
        <c:marker val="1"/>
        <c:axId val="78501376"/>
        <c:axId val="78503296"/>
      </c:lineChart>
      <c:catAx>
        <c:axId val="7850137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H</a:t>
                </a:r>
              </a:p>
            </c:rich>
          </c:tx>
          <c:layout/>
        </c:title>
        <c:numFmt formatCode="General" sourceLinked="1"/>
        <c:tickLblPos val="nextTo"/>
        <c:crossAx val="78503296"/>
        <c:crosses val="autoZero"/>
        <c:auto val="1"/>
        <c:lblAlgn val="ctr"/>
        <c:lblOffset val="100"/>
      </c:catAx>
      <c:valAx>
        <c:axId val="7850329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inoculum</a:t>
                </a:r>
              </a:p>
            </c:rich>
          </c:tx>
          <c:layout/>
        </c:title>
        <c:numFmt formatCode="0.0" sourceLinked="0"/>
        <c:tickLblPos val="nextTo"/>
        <c:crossAx val="78501376"/>
        <c:crosses val="autoZero"/>
        <c:crossBetween val="between"/>
        <c:majorUnit val="0.4"/>
      </c:valAx>
    </c:plotArea>
    <c:legend>
      <c:legendPos val="t"/>
      <c:layout/>
    </c:legend>
    <c:plotVisOnly val="1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03ECAB-1FB9-458D-A0F9-9B33365E1121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50EC17-9703-4AF5-B519-2854CBAA5CE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11FE7D-F62E-44BD-86B3-F2466AAED8D0}" type="datetimeFigureOut">
              <a:rPr lang="en-US" smtClean="0"/>
              <a:pPr/>
              <a:t>11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42115-23B3-4C2F-84ED-C0C0E5AFC00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021253" y="671252"/>
            <a:ext cx="3192780" cy="2796540"/>
            <a:chOff x="457200" y="549275"/>
            <a:chExt cx="3192780" cy="2796540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57200" y="549275"/>
              <a:ext cx="3192780" cy="2796540"/>
            </a:xfrm>
            <a:prstGeom prst="rect">
              <a:avLst/>
            </a:prstGeom>
          </p:spPr>
        </p:pic>
        <p:sp>
          <p:nvSpPr>
            <p:cNvPr id="21" name="TextBox 11"/>
            <p:cNvSpPr txBox="1"/>
            <p:nvPr/>
          </p:nvSpPr>
          <p:spPr>
            <a:xfrm>
              <a:off x="628650" y="561975"/>
              <a:ext cx="247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1200" b="1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22" name="Picture 21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15661" y="454901"/>
            <a:ext cx="3305250" cy="28658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" name="Picture 22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80197" y="3819194"/>
            <a:ext cx="3678306" cy="2210462"/>
          </a:xfrm>
          <a:prstGeom prst="rect">
            <a:avLst/>
          </a:prstGeom>
          <a:noFill/>
        </p:spPr>
      </p:pic>
      <p:pic>
        <p:nvPicPr>
          <p:cNvPr id="24" name="Picture 23"/>
          <p:cNvPicPr/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494971" y="3762044"/>
            <a:ext cx="3678307" cy="2210462"/>
          </a:xfrm>
          <a:prstGeom prst="rect">
            <a:avLst/>
          </a:prstGeom>
          <a:noFill/>
        </p:spPr>
      </p:pic>
      <p:sp>
        <p:nvSpPr>
          <p:cNvPr id="1026" name="Text Box 2"/>
          <p:cNvSpPr txBox="1">
            <a:spLocks noChangeArrowheads="1"/>
          </p:cNvSpPr>
          <p:nvPr/>
        </p:nvSpPr>
        <p:spPr bwMode="auto">
          <a:xfrm>
            <a:off x="749300" y="3727450"/>
            <a:ext cx="206375" cy="301625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4594225" y="3726000"/>
            <a:ext cx="206375" cy="301625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800975" y="304800"/>
            <a:ext cx="857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Arial" pitchFamily="34" charset="0"/>
                <a:cs typeface="Arial" pitchFamily="34" charset="0"/>
              </a:rPr>
              <a:t>Figure S3</a:t>
            </a:r>
            <a:endParaRPr lang="en-US" sz="120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2"/>
          <p:cNvSpPr txBox="1">
            <a:spLocks noChangeArrowheads="1"/>
          </p:cNvSpPr>
          <p:nvPr/>
        </p:nvSpPr>
        <p:spPr bwMode="auto">
          <a:xfrm>
            <a:off x="2955925" y="503238"/>
            <a:ext cx="206375" cy="301625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US" sz="1200" b="1">
                <a:latin typeface="Arial" pitchFamily="34" charset="0"/>
                <a:cs typeface="Arial" pitchFamily="34" charset="0"/>
              </a:rPr>
              <a:t>D</a:t>
            </a:r>
            <a:endParaRPr kumimoji="0" lang="en-US" sz="12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678677" y="3046413"/>
            <a:ext cx="7533446" cy="2224390"/>
            <a:chOff x="621527" y="2684463"/>
            <a:chExt cx="7533446" cy="2224390"/>
          </a:xfrm>
        </p:grpSpPr>
        <p:graphicFrame>
          <p:nvGraphicFramePr>
            <p:cNvPr id="4" name="Chart 3"/>
            <p:cNvGraphicFramePr/>
            <p:nvPr/>
          </p:nvGraphicFramePr>
          <p:xfrm>
            <a:off x="621527" y="2730196"/>
            <a:ext cx="3633746" cy="21786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/>
            <p:nvPr/>
          </p:nvGraphicFramePr>
          <p:xfrm>
            <a:off x="4513276" y="2728800"/>
            <a:ext cx="3641697" cy="21070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Text Box 2"/>
            <p:cNvSpPr txBox="1">
              <a:spLocks noChangeArrowheads="1"/>
            </p:cNvSpPr>
            <p:nvPr/>
          </p:nvSpPr>
          <p:spPr bwMode="auto">
            <a:xfrm>
              <a:off x="622300" y="2684463"/>
              <a:ext cx="206375" cy="301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4479925" y="2685600"/>
              <a:ext cx="206375" cy="301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F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7105650" y="304800"/>
            <a:ext cx="188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Arial" pitchFamily="34" charset="0"/>
                <a:cs typeface="Arial" pitchFamily="34" charset="0"/>
              </a:rPr>
              <a:t>Figure S3 (Continued)</a:t>
            </a:r>
            <a:endParaRPr lang="en-US" sz="120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2694001" y="510871"/>
            <a:ext cx="3662349" cy="2178657"/>
            <a:chOff x="2694001" y="510871"/>
            <a:chExt cx="3662349" cy="2178657"/>
          </a:xfrm>
        </p:grpSpPr>
        <p:graphicFrame>
          <p:nvGraphicFramePr>
            <p:cNvPr id="2" name="Chart 1"/>
            <p:cNvGraphicFramePr/>
            <p:nvPr/>
          </p:nvGraphicFramePr>
          <p:xfrm>
            <a:off x="2694001" y="510871"/>
            <a:ext cx="3641697" cy="21786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026" name="Group 2"/>
            <p:cNvGrpSpPr>
              <a:grpSpLocks/>
            </p:cNvGrpSpPr>
            <p:nvPr/>
          </p:nvGrpSpPr>
          <p:grpSpPr bwMode="auto">
            <a:xfrm>
              <a:off x="3905250" y="1139825"/>
              <a:ext cx="2451100" cy="501650"/>
              <a:chOff x="4739" y="10180"/>
              <a:chExt cx="3860" cy="790"/>
            </a:xfrm>
          </p:grpSpPr>
          <p:sp>
            <p:nvSpPr>
              <p:cNvPr id="1027" name="Text Box 3"/>
              <p:cNvSpPr txBox="1">
                <a:spLocks noChangeArrowheads="1"/>
              </p:cNvSpPr>
              <p:nvPr/>
            </p:nvSpPr>
            <p:spPr bwMode="auto">
              <a:xfrm>
                <a:off x="4739" y="10180"/>
                <a:ext cx="1515" cy="33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HIVIG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8" name="Text Box 4"/>
              <p:cNvSpPr txBox="1">
                <a:spLocks noChangeArrowheads="1"/>
              </p:cNvSpPr>
              <p:nvPr/>
            </p:nvSpPr>
            <p:spPr bwMode="auto">
              <a:xfrm>
                <a:off x="7084" y="10694"/>
                <a:ext cx="1515" cy="276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IVIG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2924341" y="1431897"/>
          <a:ext cx="3466768" cy="1860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 Box 2"/>
          <p:cNvSpPr txBox="1">
            <a:spLocks noChangeArrowheads="1"/>
          </p:cNvSpPr>
          <p:nvPr/>
        </p:nvSpPr>
        <p:spPr bwMode="auto">
          <a:xfrm>
            <a:off x="2995200" y="1265238"/>
            <a:ext cx="206375" cy="301625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G</a:t>
            </a:r>
          </a:p>
        </p:txBody>
      </p:sp>
      <p:graphicFrame>
        <p:nvGraphicFramePr>
          <p:cNvPr id="4" name="Chart 3"/>
          <p:cNvGraphicFramePr/>
          <p:nvPr/>
        </p:nvGraphicFramePr>
        <p:xfrm>
          <a:off x="2923200" y="3520522"/>
          <a:ext cx="4118776" cy="2464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2994025" y="3656013"/>
            <a:ext cx="206375" cy="301625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H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105650" y="304800"/>
            <a:ext cx="188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Arial" pitchFamily="34" charset="0"/>
                <a:cs typeface="Arial" pitchFamily="34" charset="0"/>
              </a:rPr>
              <a:t>Figure S3 (Continued)</a:t>
            </a:r>
            <a:endParaRPr lang="en-US" sz="120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50" name="Group 2"/>
          <p:cNvGrpSpPr>
            <a:grpSpLocks/>
          </p:cNvGrpSpPr>
          <p:nvPr/>
        </p:nvGrpSpPr>
        <p:grpSpPr bwMode="auto">
          <a:xfrm>
            <a:off x="3636000" y="1406525"/>
            <a:ext cx="2598738" cy="1006475"/>
            <a:chOff x="4194" y="11707"/>
            <a:chExt cx="4093" cy="1586"/>
          </a:xfrm>
        </p:grpSpPr>
        <p:sp>
          <p:nvSpPr>
            <p:cNvPr id="2051" name="Text Box 3"/>
            <p:cNvSpPr txBox="1">
              <a:spLocks noChangeArrowheads="1"/>
            </p:cNvSpPr>
            <p:nvPr/>
          </p:nvSpPr>
          <p:spPr bwMode="auto">
            <a:xfrm>
              <a:off x="4194" y="11707"/>
              <a:ext cx="351" cy="39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2" name="Text Box 4"/>
            <p:cNvSpPr txBox="1">
              <a:spLocks noChangeArrowheads="1"/>
            </p:cNvSpPr>
            <p:nvPr/>
          </p:nvSpPr>
          <p:spPr bwMode="auto">
            <a:xfrm>
              <a:off x="4682" y="11848"/>
              <a:ext cx="601" cy="41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3" name="Text Box 5"/>
            <p:cNvSpPr txBox="1">
              <a:spLocks noChangeArrowheads="1"/>
            </p:cNvSpPr>
            <p:nvPr/>
          </p:nvSpPr>
          <p:spPr bwMode="auto">
            <a:xfrm>
              <a:off x="5346" y="12336"/>
              <a:ext cx="589" cy="40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4" name="Text Box 6"/>
            <p:cNvSpPr txBox="1">
              <a:spLocks noChangeArrowheads="1"/>
            </p:cNvSpPr>
            <p:nvPr/>
          </p:nvSpPr>
          <p:spPr bwMode="auto">
            <a:xfrm>
              <a:off x="5935" y="12571"/>
              <a:ext cx="576" cy="39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5" name="Text Box 7"/>
            <p:cNvSpPr txBox="1">
              <a:spLocks noChangeArrowheads="1"/>
            </p:cNvSpPr>
            <p:nvPr/>
          </p:nvSpPr>
          <p:spPr bwMode="auto">
            <a:xfrm>
              <a:off x="6511" y="12571"/>
              <a:ext cx="551" cy="39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6" name="Text Box 8"/>
            <p:cNvSpPr txBox="1">
              <a:spLocks noChangeArrowheads="1"/>
            </p:cNvSpPr>
            <p:nvPr/>
          </p:nvSpPr>
          <p:spPr bwMode="auto">
            <a:xfrm>
              <a:off x="7174" y="12884"/>
              <a:ext cx="564" cy="40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8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7" name="Text Box 9"/>
            <p:cNvSpPr txBox="1">
              <a:spLocks noChangeArrowheads="1"/>
            </p:cNvSpPr>
            <p:nvPr/>
          </p:nvSpPr>
          <p:spPr bwMode="auto">
            <a:xfrm>
              <a:off x="7738" y="12884"/>
              <a:ext cx="549" cy="40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FFFFF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58</Words>
  <Application>Microsoft Office PowerPoint</Application>
  <PresentationFormat>On-screen Show (4:3)</PresentationFormat>
  <Paragraphs>3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 Forthal</dc:creator>
  <cp:lastModifiedBy>Don Forthal</cp:lastModifiedBy>
  <cp:revision>7</cp:revision>
  <dcterms:created xsi:type="dcterms:W3CDTF">2013-11-25T19:39:49Z</dcterms:created>
  <dcterms:modified xsi:type="dcterms:W3CDTF">2013-11-25T20:27:05Z</dcterms:modified>
</cp:coreProperties>
</file>